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47776-9918-482B-B113-27E62EB4CEC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484D91-95E6-43E6-9CB3-242BF5F6A7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2368FB-6D07-4A5D-9AC8-AEEAED30C6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A82DD-FA11-4AF0-A4D5-E9676DCB898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43172D-6EAC-4036-B3D3-8AB267DFB5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1238B0-A54D-442B-BED8-DBCC7C2349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E817A1-AB09-4B3A-83FF-7FBE9AF345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EE9AB4-C416-48E8-8C84-DA561E53EA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8BBCB-912C-45F5-94C2-C8533EF19F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A6997-D3D1-4295-9F36-027AC057A6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AAE7FE-51B3-4765-B3D9-9BDE7FE674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CC9DC0-F006-4133-B304-1437918ECE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E68EEE-B43F-41DB-9F5D-24ACCC55DED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057400" y="2362320"/>
            <a:ext cx="4876920" cy="2133360"/>
            <a:chOff x="2057400" y="2362320"/>
            <a:chExt cx="4876920" cy="2133360"/>
          </a:xfrm>
        </p:grpSpPr>
        <p:sp>
          <p:nvSpPr>
            <p:cNvPr id="42" name=""/>
            <p:cNvSpPr/>
            <p:nvPr/>
          </p:nvSpPr>
          <p:spPr>
            <a:xfrm>
              <a:off x="2057400" y="4114800"/>
              <a:ext cx="1706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USV (+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074680" y="3429000"/>
              <a:ext cx="168804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No. of male-fema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air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762000" y="2906640"/>
              <a:ext cx="9928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Wild-type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ale mi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919760" y="2906640"/>
              <a:ext cx="8254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ale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2 KO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986440" y="2870280"/>
              <a:ext cx="8254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al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4 KO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179800" y="2895480"/>
              <a:ext cx="4708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179800" y="3429000"/>
              <a:ext cx="4708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063680" y="355608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130720" y="355608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197400" y="355608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063680" y="408924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130720" y="408924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197400" y="408924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133720" y="4495680"/>
              <a:ext cx="4708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133720" y="2362320"/>
              <a:ext cx="480060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able S3: Male USVs and sexual behavior in M2 and M4 KO mi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391120" y="2895480"/>
              <a:ext cx="9151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Mic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genotyp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20T05:32:28Z</dcterms:created>
  <dc:creator>Mary X. Gao</dc:creator>
  <dc:description/>
  <dc:language>en-US</dc:language>
  <cp:lastModifiedBy>U of T</cp:lastModifiedBy>
  <dcterms:modified xsi:type="dcterms:W3CDTF">2008-03-01T18:56:39Z</dcterms:modified>
  <cp:revision>5</cp:revision>
  <dc:subject/>
  <dc:title>Slide 1</dc:title>
</cp:coreProperties>
</file>